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73FB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922"/>
    <p:restoredTop sz="96405"/>
  </p:normalViewPr>
  <p:slideViewPr>
    <p:cSldViewPr snapToGrid="0">
      <p:cViewPr varScale="1">
        <p:scale>
          <a:sx n="96" d="100"/>
          <a:sy n="96" d="100"/>
        </p:scale>
        <p:origin x="27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C2A15-5DBB-F74A-909F-0471B1CCE8E3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34358D-359D-DF4D-B16A-6BA48F09D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848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925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046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004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793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5798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236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987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318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6793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43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695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048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06FB03A5-8BE4-C14A-B806-ED4CC58880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1441" y="359030"/>
            <a:ext cx="5959368" cy="4457795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F529B287-657F-9004-BE1E-7569E0AB75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6500" y="5221025"/>
            <a:ext cx="6128663" cy="1976214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0FDB83B-CEA8-1201-288E-B969EE53E23A}"/>
              </a:ext>
            </a:extLst>
          </p:cNvPr>
          <p:cNvSpPr txBox="1"/>
          <p:nvPr/>
        </p:nvSpPr>
        <p:spPr>
          <a:xfrm>
            <a:off x="160451" y="7399975"/>
            <a:ext cx="638152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6 Fig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mparison of TPS03 isoforms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(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)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redicted exon structures of C. japonica TPS03 transcripts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(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)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alignment of amino acid sequences of two major 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anscripts, </a:t>
            </a:r>
            <a:r>
              <a:rPr lang="en-US" altLang="ja-JP" sz="14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JHT.692.8 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d </a:t>
            </a:r>
            <a:r>
              <a:rPr lang="en-US" altLang="ja-JP" sz="14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JHT</a:t>
            </a:r>
            <a:r>
              <a:rPr lang="en-US" altLang="ja-JP" sz="1400" i="1" kern="10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692.10</a:t>
            </a:r>
            <a:r>
              <a:rPr lang="en-US" altLang="ja-JP" sz="1400" kern="10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n panel A, “Exon start” indicates the start positions of exons based on the C. japonica reference genome, and “Expression” represents the summed TPM values across all samples for each isoform.</a:t>
            </a:r>
          </a:p>
          <a:p>
            <a:pPr algn="just"/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4A8C6D5-FACA-D609-AEFF-C91CD94FC8F8}"/>
              </a:ext>
            </a:extLst>
          </p:cNvPr>
          <p:cNvSpPr txBox="1"/>
          <p:nvPr/>
        </p:nvSpPr>
        <p:spPr>
          <a:xfrm>
            <a:off x="67748" y="359030"/>
            <a:ext cx="55888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)</a:t>
            </a:r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72DFE37-8DA2-2C46-6457-43D477092383}"/>
              </a:ext>
            </a:extLst>
          </p:cNvPr>
          <p:cNvSpPr txBox="1"/>
          <p:nvPr/>
        </p:nvSpPr>
        <p:spPr>
          <a:xfrm>
            <a:off x="0" y="5213243"/>
            <a:ext cx="55888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B)</a:t>
            </a:r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5461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894</TotalTime>
  <Words>87</Words>
  <Application>Microsoft Macintosh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/>
  <cp:keywords/>
  <dc:description/>
  <cp:lastModifiedBy>Ihara Tokuko</cp:lastModifiedBy>
  <cp:revision>81</cp:revision>
  <cp:lastPrinted>2023-10-10T08:11:58Z</cp:lastPrinted>
  <dcterms:created xsi:type="dcterms:W3CDTF">2023-07-12T06:47:41Z</dcterms:created>
  <dcterms:modified xsi:type="dcterms:W3CDTF">2025-08-29T07:19:21Z</dcterms:modified>
  <cp:category/>
</cp:coreProperties>
</file>